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285720" y="6072206"/>
            <a:ext cx="8643998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44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TP53 </a:t>
            </a:r>
            <a:r>
              <a:rPr lang="en-GB" sz="1600" dirty="0" smtClean="0"/>
              <a:t>gene. A) Wild (Template </a:t>
            </a:r>
            <a:r>
              <a:rPr lang="en-US" sz="1600" dirty="0" smtClean="0"/>
              <a:t>3q01_A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3q01_A  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85720" y="142852"/>
            <a:ext cx="3500462" cy="2857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14942" y="214290"/>
            <a:ext cx="3643338" cy="2911477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85720" y="3143248"/>
            <a:ext cx="3500462" cy="27860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125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14942" y="3214686"/>
            <a:ext cx="3643338" cy="2784476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88</cp:revision>
  <dcterms:created xsi:type="dcterms:W3CDTF">2018-05-10T07:33:24Z</dcterms:created>
  <dcterms:modified xsi:type="dcterms:W3CDTF">2018-05-29T07:48:28Z</dcterms:modified>
</cp:coreProperties>
</file>